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40" y="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สไลด์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D6D2BFCF-4D88-4713-E594-7F5011950E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ชื่อเรื่องรอง 2">
            <a:extLst>
              <a:ext uri="{FF2B5EF4-FFF2-40B4-BE49-F238E27FC236}">
                <a16:creationId xmlns:a16="http://schemas.microsoft.com/office/drawing/2014/main" id="{A4C70781-B459-C6AE-78F9-E897FF4F581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h-TH"/>
              <a:t>คลิกเพื่อแก้ไขสไตล์ชื่อเรื่องรอง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64FAD2A4-C250-46DB-9647-37C851F7A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D05CA-526B-4F23-B88C-CB8AB996228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B67AA7FD-2DAD-E782-996D-57BEA45C6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D1CC8851-CCD8-ED04-CD10-68D419AC14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B23C8-8754-41CF-9CE2-6DC11EF8DD1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2837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ชื่อเรื่องและข้อความ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5B68EA27-9270-6B4C-ABE0-EFA4AE78EC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FA1E3F94-0437-4251-16CC-8FF149D7C8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A54C36AA-7FDF-21F0-EB4C-1B0C3DFC1F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D05CA-526B-4F23-B88C-CB8AB996228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A51A726B-FB68-3777-126A-48F910A5F0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408F8500-05AB-BAE8-7227-A0A2CE32B1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B23C8-8754-41CF-9CE2-6DC11EF8DD1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93994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ข้อความและชื่อเรื่องแนวตั้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แนวตั้ง 1">
            <a:extLst>
              <a:ext uri="{FF2B5EF4-FFF2-40B4-BE49-F238E27FC236}">
                <a16:creationId xmlns:a16="http://schemas.microsoft.com/office/drawing/2014/main" id="{6D737E41-3A5A-D22C-CCB6-2329BBC68D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แนวตั้ง 2">
            <a:extLst>
              <a:ext uri="{FF2B5EF4-FFF2-40B4-BE49-F238E27FC236}">
                <a16:creationId xmlns:a16="http://schemas.microsoft.com/office/drawing/2014/main" id="{88351F9C-64B7-817C-AE32-D11958FC38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B0DDC7D9-2599-1E01-4605-E9F33A0202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D05CA-526B-4F23-B88C-CB8AB996228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E7DF5E14-5D57-18C0-33F2-26913D5EF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41A1B634-F9B5-A5A6-5850-9B71155924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B23C8-8754-41CF-9CE2-6DC11EF8DD1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5893178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ชื่อเรื่องและเนื้อห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51721423-BB90-595D-C853-6FF5DCF592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E9379DD4-06D5-43EA-4C5C-2A545E0AB8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682CF8E8-1075-8B00-838D-F9CF4AC298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D05CA-526B-4F23-B88C-CB8AB996228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21A158BB-AE32-5D59-0F85-0162038B9F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853749AB-A577-80AB-AEED-2E160CED1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B23C8-8754-41CF-9CE2-6DC11EF8DD1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0964454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ส่วนหัวของ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649FF84E-0394-9832-D563-6105E2C22B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D7247584-6428-F53A-0F75-523C33AD53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7CC19C76-8FCE-072F-75A3-217F82BAB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D05CA-526B-4F23-B88C-CB8AB996228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CE4F0BBE-7B7F-1905-BDFA-27C6BA3CBB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04357E4E-D4D6-DD74-682B-709F14454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B23C8-8754-41CF-9CE2-6DC11EF8DD1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473650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เนื้อหา 2 ส่ว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9BDE29E4-20F9-2EED-E6F8-34E0CCFE35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A3A48E8A-0ACC-5898-A9BD-51268D62D9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7DE0CD40-D31A-5047-340F-B73DD52297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77B59A0A-B9FB-D5D1-ADDC-1C73CF6E1C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D05CA-526B-4F23-B88C-CB8AB996228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653514D3-370E-0B35-7F13-8F545169F5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4386ED16-C383-6DE5-CFF5-C983633B8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B23C8-8754-41CF-9CE2-6DC11EF8DD1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4090144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การเปรียบเทียบ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CB998CB7-1FFC-77CC-4D0C-591588B350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923DF40A-379B-1B69-260F-9062E380C1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4" name="ตัวแทนเนื้อหา 3">
            <a:extLst>
              <a:ext uri="{FF2B5EF4-FFF2-40B4-BE49-F238E27FC236}">
                <a16:creationId xmlns:a16="http://schemas.microsoft.com/office/drawing/2014/main" id="{1C9FDE0C-9A24-B339-ADE2-47D39A6A88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5" name="ตัวแทนข้อความ 4">
            <a:extLst>
              <a:ext uri="{FF2B5EF4-FFF2-40B4-BE49-F238E27FC236}">
                <a16:creationId xmlns:a16="http://schemas.microsoft.com/office/drawing/2014/main" id="{30622BDC-02BC-4613-5AF5-6DA8144C9C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6" name="ตัวแทนเนื้อหา 5">
            <a:extLst>
              <a:ext uri="{FF2B5EF4-FFF2-40B4-BE49-F238E27FC236}">
                <a16:creationId xmlns:a16="http://schemas.microsoft.com/office/drawing/2014/main" id="{17031147-8FB1-1BF1-168B-F64343A8EB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7" name="ตัวแทนวันที่ 6">
            <a:extLst>
              <a:ext uri="{FF2B5EF4-FFF2-40B4-BE49-F238E27FC236}">
                <a16:creationId xmlns:a16="http://schemas.microsoft.com/office/drawing/2014/main" id="{2A8317A7-E56E-B052-4447-2BE885F546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D05CA-526B-4F23-B88C-CB8AB996228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8" name="ตัวแทนท้ายกระดาษ 7">
            <a:extLst>
              <a:ext uri="{FF2B5EF4-FFF2-40B4-BE49-F238E27FC236}">
                <a16:creationId xmlns:a16="http://schemas.microsoft.com/office/drawing/2014/main" id="{89E2FD42-28BD-8E92-61C4-5AB0F8F2D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ตัวแทนหมายเลขสไลด์ 8">
            <a:extLst>
              <a:ext uri="{FF2B5EF4-FFF2-40B4-BE49-F238E27FC236}">
                <a16:creationId xmlns:a16="http://schemas.microsoft.com/office/drawing/2014/main" id="{7F44B87A-A79E-2E3A-4079-C4DC8CC58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B23C8-8754-41CF-9CE2-6DC11EF8DD1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1029347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เฉพาะชื่อเรื่อ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39B79770-C032-129A-C5EF-3338E02321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วันที่ 2">
            <a:extLst>
              <a:ext uri="{FF2B5EF4-FFF2-40B4-BE49-F238E27FC236}">
                <a16:creationId xmlns:a16="http://schemas.microsoft.com/office/drawing/2014/main" id="{6028884E-CCE5-A8F7-699C-4190A1775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D05CA-526B-4F23-B88C-CB8AB996228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4" name="ตัวแทนท้ายกระดาษ 3">
            <a:extLst>
              <a:ext uri="{FF2B5EF4-FFF2-40B4-BE49-F238E27FC236}">
                <a16:creationId xmlns:a16="http://schemas.microsoft.com/office/drawing/2014/main" id="{D91B6132-1D27-A1E0-79FF-23F74C4E28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ตัวแทนหมายเลขสไลด์ 4">
            <a:extLst>
              <a:ext uri="{FF2B5EF4-FFF2-40B4-BE49-F238E27FC236}">
                <a16:creationId xmlns:a16="http://schemas.microsoft.com/office/drawing/2014/main" id="{45CF616D-A8A3-61F5-D7AC-BFFB698803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B23C8-8754-41CF-9CE2-6DC11EF8DD1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057560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ว่างเปล่า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วันที่ 1">
            <a:extLst>
              <a:ext uri="{FF2B5EF4-FFF2-40B4-BE49-F238E27FC236}">
                <a16:creationId xmlns:a16="http://schemas.microsoft.com/office/drawing/2014/main" id="{403EA238-CE7D-04E4-6274-773963338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D05CA-526B-4F23-B88C-CB8AB996228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3" name="ตัวแทนท้ายกระดาษ 2">
            <a:extLst>
              <a:ext uri="{FF2B5EF4-FFF2-40B4-BE49-F238E27FC236}">
                <a16:creationId xmlns:a16="http://schemas.microsoft.com/office/drawing/2014/main" id="{7544C4EF-9AC5-923A-F9C7-CDC15BF494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ตัวแทนหมายเลขสไลด์ 3">
            <a:extLst>
              <a:ext uri="{FF2B5EF4-FFF2-40B4-BE49-F238E27FC236}">
                <a16:creationId xmlns:a16="http://schemas.microsoft.com/office/drawing/2014/main" id="{59D962DE-508C-3AD3-5A8A-EAA00912A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B23C8-8754-41CF-9CE2-6DC11EF8DD1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007902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เนื้อหา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CA0BAD6D-4413-7E67-406C-FB9EAE1EC9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เนื้อหา 2">
            <a:extLst>
              <a:ext uri="{FF2B5EF4-FFF2-40B4-BE49-F238E27FC236}">
                <a16:creationId xmlns:a16="http://schemas.microsoft.com/office/drawing/2014/main" id="{B0DA49B9-412D-CB43-6C4C-7569671857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193118BD-33E2-C25D-3FB1-6512FDD1D5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90E8735A-A52D-D1F3-AC56-8DE152CA8D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D05CA-526B-4F23-B88C-CB8AB996228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9255431A-0700-4D54-D8CD-3B05AF8A78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928F9F05-CE35-71DF-5AF8-42D43ABDD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B23C8-8754-41CF-9CE2-6DC11EF8DD1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4250343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รูปภาพพร้อมคำอธิบายภาพ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ชื่อเรื่อง 1">
            <a:extLst>
              <a:ext uri="{FF2B5EF4-FFF2-40B4-BE49-F238E27FC236}">
                <a16:creationId xmlns:a16="http://schemas.microsoft.com/office/drawing/2014/main" id="{B404EB74-EA5D-9A53-9853-EF4598FE27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รูปภาพ 2">
            <a:extLst>
              <a:ext uri="{FF2B5EF4-FFF2-40B4-BE49-F238E27FC236}">
                <a16:creationId xmlns:a16="http://schemas.microsoft.com/office/drawing/2014/main" id="{7908E84B-8C78-D082-4F60-E7A158EC2D1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h-TH"/>
          </a:p>
        </p:txBody>
      </p:sp>
      <p:sp>
        <p:nvSpPr>
          <p:cNvPr id="4" name="ตัวแทนข้อความ 3">
            <a:extLst>
              <a:ext uri="{FF2B5EF4-FFF2-40B4-BE49-F238E27FC236}">
                <a16:creationId xmlns:a16="http://schemas.microsoft.com/office/drawing/2014/main" id="{DF227788-CA4D-86C4-D178-FC58DB0641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h-TH"/>
              <a:t>คลิกเพื่อแก้ไขสไตล์ของข้อความต้นแบบ</a:t>
            </a:r>
          </a:p>
        </p:txBody>
      </p:sp>
      <p:sp>
        <p:nvSpPr>
          <p:cNvPr id="5" name="ตัวแทนวันที่ 4">
            <a:extLst>
              <a:ext uri="{FF2B5EF4-FFF2-40B4-BE49-F238E27FC236}">
                <a16:creationId xmlns:a16="http://schemas.microsoft.com/office/drawing/2014/main" id="{B01DA98E-3A3C-756B-DE70-F339A2F3D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4D05CA-526B-4F23-B88C-CB8AB996228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6" name="ตัวแทนท้ายกระดาษ 5">
            <a:extLst>
              <a:ext uri="{FF2B5EF4-FFF2-40B4-BE49-F238E27FC236}">
                <a16:creationId xmlns:a16="http://schemas.microsoft.com/office/drawing/2014/main" id="{0CADE838-2C3B-B0C9-51F9-4E1DC6A032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ตัวแทนหมายเลขสไลด์ 6">
            <a:extLst>
              <a:ext uri="{FF2B5EF4-FFF2-40B4-BE49-F238E27FC236}">
                <a16:creationId xmlns:a16="http://schemas.microsoft.com/office/drawing/2014/main" id="{42636A29-6BCA-6374-A814-9ACAB18260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4B23C8-8754-41CF-9CE2-6DC11EF8DD1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608376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ตัวแทนชื่อเรื่อง 1">
            <a:extLst>
              <a:ext uri="{FF2B5EF4-FFF2-40B4-BE49-F238E27FC236}">
                <a16:creationId xmlns:a16="http://schemas.microsoft.com/office/drawing/2014/main" id="{AB01A8AE-5CF8-B742-24A8-AB172B3898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h-TH"/>
              <a:t>คลิกเพื่อแก้ไขสไตล์ชื่อเรื่องต้นแบบ</a:t>
            </a:r>
          </a:p>
        </p:txBody>
      </p:sp>
      <p:sp>
        <p:nvSpPr>
          <p:cNvPr id="3" name="ตัวแทนข้อความ 2">
            <a:extLst>
              <a:ext uri="{FF2B5EF4-FFF2-40B4-BE49-F238E27FC236}">
                <a16:creationId xmlns:a16="http://schemas.microsoft.com/office/drawing/2014/main" id="{8FCEBEF6-FF5E-71F2-F6DD-2528DB5465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h-TH"/>
              <a:t>คลิกเพื่อแก้ไขสไตล์ของข้อความต้นแบบ</a:t>
            </a:r>
          </a:p>
          <a:p>
            <a:pPr lvl="1"/>
            <a:r>
              <a:rPr lang="th-TH"/>
              <a:t>ระดับที่สอง</a:t>
            </a:r>
          </a:p>
          <a:p>
            <a:pPr lvl="2"/>
            <a:r>
              <a:rPr lang="th-TH"/>
              <a:t>ระดับที่สาม</a:t>
            </a:r>
          </a:p>
          <a:p>
            <a:pPr lvl="3"/>
            <a:r>
              <a:rPr lang="th-TH"/>
              <a:t>ระดับที่สี่</a:t>
            </a:r>
          </a:p>
          <a:p>
            <a:pPr lvl="4"/>
            <a:r>
              <a:rPr lang="th-TH"/>
              <a:t>ระดับที่ห้า</a:t>
            </a:r>
          </a:p>
        </p:txBody>
      </p:sp>
      <p:sp>
        <p:nvSpPr>
          <p:cNvPr id="4" name="ตัวแทนวันที่ 3">
            <a:extLst>
              <a:ext uri="{FF2B5EF4-FFF2-40B4-BE49-F238E27FC236}">
                <a16:creationId xmlns:a16="http://schemas.microsoft.com/office/drawing/2014/main" id="{46210AA7-F05E-607D-B73E-9BD53C8FFC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4D05CA-526B-4F23-B88C-CB8AB996228A}" type="datetimeFigureOut">
              <a:rPr lang="th-TH" smtClean="0"/>
              <a:t>22/02/69</a:t>
            </a:fld>
            <a:endParaRPr lang="th-TH"/>
          </a:p>
        </p:txBody>
      </p:sp>
      <p:sp>
        <p:nvSpPr>
          <p:cNvPr id="5" name="ตัวแทนท้ายกระดาษ 4">
            <a:extLst>
              <a:ext uri="{FF2B5EF4-FFF2-40B4-BE49-F238E27FC236}">
                <a16:creationId xmlns:a16="http://schemas.microsoft.com/office/drawing/2014/main" id="{0435A4BC-ABFA-5CCD-6DE9-1AC08488E1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ตัวแทนหมายเลขสไลด์ 5">
            <a:extLst>
              <a:ext uri="{FF2B5EF4-FFF2-40B4-BE49-F238E27FC236}">
                <a16:creationId xmlns:a16="http://schemas.microsoft.com/office/drawing/2014/main" id="{DD3172C3-3F93-125A-819B-E52EB1619EF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4B23C8-8754-41CF-9CE2-6DC11EF8DD18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6725641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h-TH"/>
      </a:defPPr>
      <a:lvl1pPr marL="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screenshot of a data&#10;&#10;AI-generated content may be incorrect.">
            <a:extLst>
              <a:ext uri="{FF2B5EF4-FFF2-40B4-BE49-F238E27FC236}">
                <a16:creationId xmlns:a16="http://schemas.microsoft.com/office/drawing/2014/main" id="{BF124C37-981E-5446-470E-38548C172E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61574" y="1048858"/>
            <a:ext cx="3252034" cy="3778625"/>
          </a:xfrm>
          <a:prstGeom prst="rect">
            <a:avLst/>
          </a:prstGeom>
        </p:spPr>
      </p:pic>
      <p:sp>
        <p:nvSpPr>
          <p:cNvPr id="4" name="กล่องข้อความ 3">
            <a:extLst>
              <a:ext uri="{FF2B5EF4-FFF2-40B4-BE49-F238E27FC236}">
                <a16:creationId xmlns:a16="http://schemas.microsoft.com/office/drawing/2014/main" id="{F91BB518-A23F-A44C-4A55-B3E2130199F7}"/>
              </a:ext>
            </a:extLst>
          </p:cNvPr>
          <p:cNvSpPr txBox="1"/>
          <p:nvPr/>
        </p:nvSpPr>
        <p:spPr>
          <a:xfrm>
            <a:off x="1207698" y="4827483"/>
            <a:ext cx="10437962" cy="2802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  <a:buNone/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pplementary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</a:t>
            </a:r>
            <a:r>
              <a:rPr lang="en-IN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Figure S12: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The analysis of variance (ANOVA) results from the response surface regression for </a:t>
            </a: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ngsana New" panose="02020603050405020304" pitchFamily="18" charset="-34"/>
              </a:rPr>
              <a:t>%EE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3659528252"/>
      </p:ext>
    </p:extLst>
  </p:cSld>
  <p:clrMapOvr>
    <a:masterClrMapping/>
  </p:clrMapOvr>
</p:sld>
</file>

<file path=ppt/theme/theme1.xml><?xml version="1.0" encoding="utf-8"?>
<a:theme xmlns:a="http://schemas.openxmlformats.org/drawingml/2006/main" name="ธีมของ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0</Words>
  <Application>Microsoft Office PowerPoint</Application>
  <PresentationFormat>แบบจอกว้าง</PresentationFormat>
  <Paragraphs>1</Paragraphs>
  <Slides>1</Slides>
  <Notes>0</Notes>
  <HiddenSlides>0</HiddenSlides>
  <MMClips>0</MMClips>
  <ScaleCrop>false</ScaleCrop>
  <HeadingPairs>
    <vt:vector size="6" baseType="variant">
      <vt:variant>
        <vt:lpstr>ฟอนต์ที่ถูกใช้</vt:lpstr>
      </vt:variant>
      <vt:variant>
        <vt:i4>4</vt:i4>
      </vt:variant>
      <vt:variant>
        <vt:lpstr>ธีม</vt:lpstr>
      </vt:variant>
      <vt:variant>
        <vt:i4>1</vt:i4>
      </vt:variant>
      <vt:variant>
        <vt:lpstr>ชื่อเรื่องสไลด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ธีมของ Office</vt:lpstr>
      <vt:lpstr>งานนำเสนอ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กิ่งกาญจน์ บรรลือพืช</dc:creator>
  <cp:lastModifiedBy>กิ่งกาญจน์ บรรลือพืช</cp:lastModifiedBy>
  <cp:revision>1</cp:revision>
  <dcterms:created xsi:type="dcterms:W3CDTF">2026-02-22T09:12:41Z</dcterms:created>
  <dcterms:modified xsi:type="dcterms:W3CDTF">2026-02-22T09:14:19Z</dcterms:modified>
</cp:coreProperties>
</file>